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581A2F-C134-4DA5-AF82-CFFE1E51A57D}" type="slidenum"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1EE7CE-FF1A-4F5C-BEAA-16FA77862E89}" type="slidenum"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DE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B86494-C0C1-4DDC-A900-2B51196122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810A2-7043-4B19-B6E9-3282C5B318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1D1AE-6493-4B0D-A097-2F416FAB76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F6680-E8A8-4467-9823-6A8197CED4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EB41DF-7AAD-46BA-902A-EF41358395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07049-EEDF-4392-A8D0-61B0565C63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9E0AF-2957-4D42-A27D-EE1ED69E57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A07E7-D2B7-4D7D-AEF6-C77B51789C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E448CA-4287-4DEB-8F9D-CCEEDE9C5B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1782F-1E4C-4BA0-821C-855B97FDED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A3B2B-FDE7-4993-8272-560BEFC2F5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CBC5E-96CC-4C3A-818F-44B6D21CCC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782969-2B8D-4FDF-821F-F2766C3ADE34}" type="slidenum"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14480" y="2139840"/>
          <a:ext cx="8915400" cy="2562480"/>
        </p:xfrm>
        <a:graphic>
          <a:graphicData uri="http://schemas.openxmlformats.org/drawingml/2006/table">
            <a:tbl>
              <a:tblPr/>
              <a:tblGrid>
                <a:gridCol w="1295280"/>
                <a:gridCol w="2539800"/>
                <a:gridCol w="2540160"/>
                <a:gridCol w="2540160"/>
              </a:tblGrid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Ge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solidFill>
                      <a:srgbClr val="f3f3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Forward Primer (5’-3’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solidFill>
                      <a:srgbClr val="f3f3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Reverse Primer (3’-5’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solidFill>
                      <a:srgbClr val="f3f3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t-BR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Probe (5’-FAM, 3’-TAMR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solidFill>
                      <a:srgbClr val="f3f3f3"/>
                    </a:solidFill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r" pos="600228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P (rat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CCTCTTCCTGGCCTTTTG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TGTGTTGGACACCGCACTG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TCCCAGGCCATATTGGAGCAAAT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r" pos="600228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NP (rat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GCTGCAGACTCCGGCTT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ATCACTTGAGAGGTGGTCC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ACTCTGCCTGCGGCTCTTCTTTC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r" pos="600228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l3A1 (rat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TGGCGGCTTTTCACCATA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ACTCTCTATTTGTCCGTTAACAGACTT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CCAATGGATTTCAAGATCAACACT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r" pos="600228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MP-1 (rat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TGTCCACAAGTCCCAGAA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ATGTGCAAATTTCCGTTC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AGTTTCTCATCGCGGGCCGT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r" pos="600228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32 (rat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GAAAGAGCAGCACAGCTG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TCATTCTCTTCGCTGCGT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TCAGAGTCACCAATCCCAACGC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r" pos="600228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OS (huma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AGATCTCCGCCTCGCTC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AGCCATACAGGATTGTCG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CACGGTGATGGCGAAGCGAGT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r" pos="600228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GC alpha 1 (huma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TCAACTCGCTTCGACCAG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ACAATAGGCATCGCCAATG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TGTGGAGAGCTGGATGTCTACAAGGTG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r" pos="600228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GC beta 1 (huma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GTCCTTCCTCCGTCTGTT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TGTCATATCTTTTGGCAGGCA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ATGAGCTGCGGCACAAGCGT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r" pos="600228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DE5 (huma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GGAGACAGAGAGAGAAAAGAACT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CCAACTTGCATACTTGGGA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CCCACTGATCTAATGAACAGGGAGAA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r" pos="600228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32 (huma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AAGTTCATCCGGCACCAG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TGGCCCTTGAATCTTCTAC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PMingLiU"/>
                        </a:rPr>
                        <a:t>CCCAGAGGCATTGACAACAGG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808080"/>
                      </a:solidFill>
                    </a:lnL>
                    <a:lnR w="5760">
                      <a:solidFill>
                        <a:srgbClr val="808080"/>
                      </a:solidFill>
                    </a:lnR>
                    <a:lnT w="5760">
                      <a:solidFill>
                        <a:srgbClr val="80808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Rectangle 861"/>
          <p:cNvSpPr/>
          <p:nvPr/>
        </p:nvSpPr>
        <p:spPr>
          <a:xfrm>
            <a:off x="66600" y="4799880"/>
            <a:ext cx="457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FAM, carboxyfluorescein; TAMRA, carboxytetramethylrhodam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4T09:15:35Z</dcterms:created>
  <dc:creator>Faye</dc:creator>
  <dc:description/>
  <dc:language>en-US</dc:language>
  <cp:lastModifiedBy>Nickel</cp:lastModifiedBy>
  <dcterms:modified xsi:type="dcterms:W3CDTF">2013-05-16T17:31:53Z</dcterms:modified>
  <cp:revision>4</cp:revision>
  <dc:subject/>
  <dc:title>Folie 1</dc:title>
</cp:coreProperties>
</file>